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261E4-6D46-46C9-9CA0-0DAEA0644E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8F198B-D0BD-4C81-885A-3C1E6ACA7F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32A40-BBC8-49A4-A423-4D3E796C9B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E5D0E-37A8-4021-9E50-0BBCCD8941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655F53-9004-434C-B9AB-3F4F3F464C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438C53-85A5-4824-BAEC-D88A193090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860AB-7C7A-47E4-BC8C-1ED077FA7D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F3DDE-B7F4-4E07-8BC6-7354D9A335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8EB16C-9725-4B05-836A-CF7F1265FB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AEC35-FD3F-4875-8E3B-C412846499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802828-6792-4EB1-8CD0-BA8ED0455A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3785B6-0C5F-445F-B927-E448A8416C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17FAE3E-905E-4290-B6E7-F9AFCFFB3DD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153000" y="152280"/>
            <a:ext cx="249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.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" descr=""/>
          <p:cNvPicPr/>
          <p:nvPr/>
        </p:nvPicPr>
        <p:blipFill>
          <a:blip r:embed="rId1"/>
          <a:stretch/>
        </p:blipFill>
        <p:spPr>
          <a:xfrm>
            <a:off x="1762200" y="1703520"/>
            <a:ext cx="2049480" cy="2259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Picture 5" descr=""/>
          <p:cNvPicPr/>
          <p:nvPr/>
        </p:nvPicPr>
        <p:blipFill>
          <a:blip r:embed="rId2"/>
          <a:srcRect l="28797" t="0" r="0" b="0"/>
          <a:stretch/>
        </p:blipFill>
        <p:spPr>
          <a:xfrm>
            <a:off x="6210360" y="1676520"/>
            <a:ext cx="1028520" cy="228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TextBox 18"/>
          <p:cNvSpPr/>
          <p:nvPr/>
        </p:nvSpPr>
        <p:spPr>
          <a:xfrm rot="16200000">
            <a:off x="1708920" y="1044720"/>
            <a:ext cx="94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Control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20"/>
          <p:cNvSpPr/>
          <p:nvPr/>
        </p:nvSpPr>
        <p:spPr>
          <a:xfrm rot="16200000">
            <a:off x="2575800" y="1044720"/>
            <a:ext cx="94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Lapatinib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6"/>
          <p:cNvSpPr/>
          <p:nvPr/>
        </p:nvSpPr>
        <p:spPr>
          <a:xfrm>
            <a:off x="3895560" y="2084400"/>
            <a:ext cx="91440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250 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150 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100 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75 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8"/>
          <p:cNvSpPr/>
          <p:nvPr/>
        </p:nvSpPr>
        <p:spPr>
          <a:xfrm rot="16200000">
            <a:off x="5972760" y="1043280"/>
            <a:ext cx="94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Control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20"/>
          <p:cNvSpPr/>
          <p:nvPr/>
        </p:nvSpPr>
        <p:spPr>
          <a:xfrm rot="16200000">
            <a:off x="6401520" y="1043280"/>
            <a:ext cx="94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Lapatinib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20"/>
          <p:cNvSpPr/>
          <p:nvPr/>
        </p:nvSpPr>
        <p:spPr>
          <a:xfrm rot="16200000">
            <a:off x="3182040" y="1044720"/>
            <a:ext cx="94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 Narrow"/>
              </a:rPr>
              <a:t>Marker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9"/>
          <p:cNvSpPr/>
          <p:nvPr/>
        </p:nvSpPr>
        <p:spPr>
          <a:xfrm>
            <a:off x="992520" y="83808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0"/>
          <p:cNvSpPr/>
          <p:nvPr/>
        </p:nvSpPr>
        <p:spPr>
          <a:xfrm>
            <a:off x="5326200" y="83808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21"/>
          <p:cNvSpPr/>
          <p:nvPr/>
        </p:nvSpPr>
        <p:spPr>
          <a:xfrm>
            <a:off x="1100520" y="441972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6"/>
          <p:cNvSpPr/>
          <p:nvPr/>
        </p:nvSpPr>
        <p:spPr>
          <a:xfrm>
            <a:off x="1981080" y="4694400"/>
            <a:ext cx="19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P: PT66 / WB: FAS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37"/>
          <p:cNvSpPr/>
          <p:nvPr/>
        </p:nvSpPr>
        <p:spPr>
          <a:xfrm>
            <a:off x="2095560" y="6189840"/>
            <a:ext cx="723960" cy="54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KBR3       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38"/>
          <p:cNvSpPr/>
          <p:nvPr/>
        </p:nvSpPr>
        <p:spPr>
          <a:xfrm>
            <a:off x="3162240" y="6178680"/>
            <a:ext cx="459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T47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39"/>
          <p:cNvSpPr/>
          <p:nvPr/>
        </p:nvSpPr>
        <p:spPr>
          <a:xfrm>
            <a:off x="2021400" y="5151600"/>
            <a:ext cx="1914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        Lap        C       Lap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6"/>
          <p:cNvSpPr/>
          <p:nvPr/>
        </p:nvSpPr>
        <p:spPr>
          <a:xfrm>
            <a:off x="4038480" y="5562720"/>
            <a:ext cx="129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Y-FAS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20"/>
          <p:cNvSpPr/>
          <p:nvPr/>
        </p:nvSpPr>
        <p:spPr>
          <a:xfrm>
            <a:off x="1919160" y="6066000"/>
            <a:ext cx="887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1"/>
          <p:cNvSpPr/>
          <p:nvPr/>
        </p:nvSpPr>
        <p:spPr>
          <a:xfrm>
            <a:off x="2943360" y="6066000"/>
            <a:ext cx="887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23" descr=""/>
          <p:cNvPicPr/>
          <p:nvPr/>
        </p:nvPicPr>
        <p:blipFill>
          <a:blip r:embed="rId3"/>
          <a:stretch/>
        </p:blipFill>
        <p:spPr>
          <a:xfrm>
            <a:off x="1762200" y="5456160"/>
            <a:ext cx="2238480" cy="533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1" name="Rectangle 6"/>
          <p:cNvSpPr/>
          <p:nvPr/>
        </p:nvSpPr>
        <p:spPr>
          <a:xfrm>
            <a:off x="7391520" y="1752480"/>
            <a:ext cx="990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P: PT66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WB: PT6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07T16:26:05Z</dcterms:created>
  <dc:creator>QJin</dc:creator>
  <dc:description/>
  <dc:language>en-US</dc:language>
  <cp:lastModifiedBy>fjesteva</cp:lastModifiedBy>
  <dcterms:modified xsi:type="dcterms:W3CDTF">2010-07-08T15:39:47Z</dcterms:modified>
  <cp:revision>6</cp:revision>
  <dc:subject/>
  <dc:title>Slide 1</dc:title>
</cp:coreProperties>
</file>